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65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405" autoAdjust="0"/>
    <p:restoredTop sz="94660"/>
  </p:normalViewPr>
  <p:slideViewPr>
    <p:cSldViewPr snapToGrid="0">
      <p:cViewPr>
        <p:scale>
          <a:sx n="50" d="100"/>
          <a:sy n="50" d="100"/>
        </p:scale>
        <p:origin x="1224" y="1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AC32B8-2261-4D41-94A2-F3724814F201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156137-F49D-4484-901F-42CA934C6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8389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156137-F49D-4484-901F-42CA934C674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6538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572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248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007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169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56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780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867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906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598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755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141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20F4F6-CB0D-49BA-955C-7D271FC07806}" type="datetimeFigureOut">
              <a:rPr lang="en-US" smtClean="0"/>
              <a:t>1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61C60B-839E-4168-B36B-9E127BCE55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4387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70" t="20176" r="23201" b="10000"/>
          <a:stretch/>
        </p:blipFill>
        <p:spPr>
          <a:xfrm>
            <a:off x="5867401" y="0"/>
            <a:ext cx="6324599" cy="678488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17714" y="5138058"/>
            <a:ext cx="280488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Unstructured data: Evidence-based recommendations from published clinical guideline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78163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8233691"/>
              </p:ext>
            </p:extLst>
          </p:nvPr>
        </p:nvGraphicFramePr>
        <p:xfrm>
          <a:off x="3443378" y="0"/>
          <a:ext cx="8748622" cy="68580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38516"/>
                <a:gridCol w="733817"/>
                <a:gridCol w="800528"/>
                <a:gridCol w="2411113"/>
                <a:gridCol w="2001318"/>
                <a:gridCol w="2163330"/>
              </a:tblGrid>
              <a:tr h="64839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omain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Guideline Table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ge Range from Guideline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ext From Guidelines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DS Rule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ecommendation Displayed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</a:tr>
              <a:tr h="1945176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OvOb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0-1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0 - 24m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 dirty="0">
                          <a:effectLst/>
                        </a:rPr>
                        <a:t>No weight-for-height specific recommendations </a:t>
                      </a:r>
                      <a:br>
                        <a:rPr lang="en-US" sz="1200" dirty="0">
                          <a:effectLst/>
                        </a:rPr>
                      </a:br>
                      <a:r>
                        <a:rPr lang="en-US" sz="1200" dirty="0">
                          <a:effectLst/>
                        </a:rPr>
                        <a:t>CHILD 1 diet is recommended for pediatric care providers to use with their child and adolescent patients to reduce CV risk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 dirty="0">
                          <a:effectLst/>
                        </a:rPr>
                        <a:t>IF  pi_ageInMonths =0&lt;24 THEN OO1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>
                          <a:effectLst/>
                        </a:rPr>
                        <a:t>OO1= No weight for height specific recommendations. CHILD 1 diet is recommended for pediatric care providers to use with their child and adolescent patients to reduce CV risk. 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</a:tr>
              <a:tr h="426443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OvOb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0-1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 - 5 y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 dirty="0">
                          <a:effectLst/>
                        </a:rPr>
                        <a:t>Identify children at high risk for obesity because of parental obesity and excessive BMI increase </a:t>
                      </a:r>
                      <a:br>
                        <a:rPr lang="en-US" sz="1200" dirty="0">
                          <a:effectLst/>
                        </a:rPr>
                      </a:br>
                      <a:r>
                        <a:rPr lang="en-US" sz="1200" dirty="0">
                          <a:effectLst/>
                        </a:rPr>
                        <a:t>→Focused CHILD 1 diet and physical activity education 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 dirty="0">
                          <a:effectLst/>
                        </a:rPr>
                        <a:t>BMI percentile stable→ reinforce current program, follow up in 6 months</a:t>
                      </a:r>
                    </a:p>
                    <a:p>
                      <a:pPr marL="342900" marR="0" lvl="0" indent="-34290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 dirty="0">
                          <a:effectLst/>
                        </a:rPr>
                        <a:t> Increasing BMI percentile→ registered dietitian (RD) counseling for energy balanced diet, intensify physical activity change; 6 month follow up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342900" marR="0" lvl="0" indent="-342900" algn="l" defTabSz="914400" rtl="0" eaLnBrk="1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F  pi_ageInMonths = 24&lt;72 AND pi_hasParentObesity = “Y” AND pi_deltaBMI = excessiveIncrease THEN </a:t>
                      </a:r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O2</a:t>
                      </a:r>
                    </a:p>
                    <a:p>
                      <a:pPr marL="342900" marR="0" lvl="0" indent="-342900" algn="l" defTabSz="914400" rtl="0" eaLnBrk="1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F  pi_ageInMonths = 24&lt;72 AND pi_deltaBMI  = stable AND pi_bmiPercentile  &lt; 85 THEN OO4</a:t>
                      </a:r>
                    </a:p>
                    <a:p>
                      <a:pPr marL="342900" marR="0" lvl="0" indent="-342900" algn="l" defTabSz="914400" rtl="0" eaLnBrk="1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F  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i_ageInMonths = 24&lt;72 AND pi_bmiPercentile  &lt; 85 and pi_deltaBMI =increasing OR pi_deltaBMI = excessiveIncrease THEN OO5</a:t>
                      </a:r>
                    </a:p>
                  </a:txBody>
                  <a:tcPr marL="47817" marR="47817" marT="0" marB="0"/>
                </a:tc>
                <a:tc>
                  <a:txBody>
                    <a:bodyPr/>
                    <a:lstStyle/>
                    <a:p>
                      <a:pPr marL="342900" marR="0" lvl="0" indent="-342900" algn="l" defTabSz="914400" rtl="0" eaLnBrk="1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O2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= Provide focused CHILD1 and physical activity education (B</a:t>
                      </a:r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.</a:t>
                      </a:r>
                      <a:endParaRPr lang="en-US" sz="12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342900" marR="0" lvl="0" indent="-342900" algn="l" defTabSz="914400" rtl="0" eaLnBrk="1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O4=Reinforce current program, follow up in 6 months (B).    </a:t>
                      </a:r>
                    </a:p>
                    <a:p>
                      <a:pPr marL="342900" marR="0" lvl="0" indent="-342900" algn="l" defTabSz="914400" rtl="0" eaLnBrk="1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AutoNum type="arabicPeriod"/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O5= RD counseling for energy balanced diet, intensify physical activity change. Follow up in 6 months. </a:t>
                      </a:r>
                    </a:p>
                  </a:txBody>
                  <a:tcPr marL="47817" marR="47817" marT="0" marB="0"/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42900" y="5118100"/>
            <a:ext cx="23622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Semistructured</a:t>
            </a:r>
            <a:r>
              <a:rPr lang="en-US" dirty="0" smtClean="0"/>
              <a:t> data: Inventory of guideline recommendations, triggers, and respons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616515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1900521"/>
              </p:ext>
            </p:extLst>
          </p:nvPr>
        </p:nvGraphicFramePr>
        <p:xfrm>
          <a:off x="1577675" y="0"/>
          <a:ext cx="10614325" cy="51108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48672"/>
                <a:gridCol w="429039"/>
                <a:gridCol w="706150"/>
                <a:gridCol w="606700"/>
                <a:gridCol w="815045"/>
                <a:gridCol w="606700"/>
                <a:gridCol w="581790"/>
                <a:gridCol w="638629"/>
                <a:gridCol w="415228"/>
                <a:gridCol w="600772"/>
                <a:gridCol w="261257"/>
                <a:gridCol w="1430874"/>
                <a:gridCol w="2473469"/>
              </a:tblGrid>
              <a:tr h="11118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pi_ageInMonth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0&lt;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 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OO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romote CHILD 1 Diet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</a:rPr>
                        <a:t>No weight for height specific recommendations. CHILD 1 diet is recommended  for pediatric care providers to use with their child  and adolescent patients to reduce CV risk.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</a:tr>
              <a:tr h="6641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ageInMonth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24&lt;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hasParentObesit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deltaBM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excessiveIncrea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OO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romote CHILD 1 Diet and PA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Provide focused CHILD1  and physical activity education (Grade B).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</a:tr>
              <a:tr h="6641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ageInMonth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24&lt;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deltaBM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st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bmiPercenti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&lt;8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OO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Reinforce Program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Reinforce current program, follow up in 6 months (Grade B).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</a:tr>
              <a:tr h="6687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ageInMonth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24&lt;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bmiPercenti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&lt;8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|pi_deltaBMI</a:t>
                      </a:r>
                      <a:endParaRPr lang="en-US" sz="1200" b="0" i="0" u="none" strike="noStrike">
                        <a:solidFill>
                          <a:srgbClr val="9C0006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excessiveIncrease</a:t>
                      </a:r>
                      <a:endParaRPr lang="en-US" sz="1200" b="0" i="0" u="none" strike="noStrike" dirty="0">
                        <a:solidFill>
                          <a:srgbClr val="9C0006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|pi_deltaBMI</a:t>
                      </a:r>
                      <a:endParaRPr lang="en-US" sz="1200" b="0" i="0" u="none" strike="noStrike">
                        <a:solidFill>
                          <a:srgbClr val="9C0006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ncreasing</a:t>
                      </a:r>
                      <a:endParaRPr lang="en-US" sz="1200" b="0" i="0" u="none" strike="noStrike">
                        <a:solidFill>
                          <a:srgbClr val="9C0006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 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OO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RD Counseling and P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RD counseling  for energy balanced diet, intensify physical activity change. Follow up in 6 months.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</a:tr>
              <a:tr h="11118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ageInMonth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24&lt;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bmiPercenti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85&lt;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!pi_deltaBMI</a:t>
                      </a:r>
                      <a:endParaRPr lang="en-US" sz="1200" b="0" i="0" u="none" strike="noStrike">
                        <a:solidFill>
                          <a:srgbClr val="0061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ncreasing</a:t>
                      </a:r>
                      <a:endParaRPr lang="en-US" sz="1200" b="0" i="0" u="none" strike="noStrike">
                        <a:solidFill>
                          <a:srgbClr val="0061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!pi_deltaBMI</a:t>
                      </a:r>
                      <a:endParaRPr lang="en-US" sz="1200" b="0" i="0" u="none" strike="noStrike">
                        <a:solidFill>
                          <a:srgbClr val="0061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mproving</a:t>
                      </a:r>
                      <a:endParaRPr lang="en-US" sz="1200" b="0" i="0" u="none" strike="noStrike">
                        <a:solidFill>
                          <a:srgbClr val="0061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!pi_deltaBMI</a:t>
                      </a:r>
                      <a:endParaRPr lang="en-US" sz="1200" b="0" i="0" u="none" strike="noStrike" dirty="0">
                        <a:solidFill>
                          <a:srgbClr val="0061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excessiveIncrease</a:t>
                      </a:r>
                      <a:endParaRPr lang="en-US" sz="1200" b="0" i="0" u="none" strike="noStrike">
                        <a:solidFill>
                          <a:srgbClr val="0061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OO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Weight Gain Prevention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</a:rPr>
                        <a:t>Discuss excess weight gain prevention with parents as focus for energy-balanced diet. Reinforce physical activity recommendations. Follow up in 6 months (Grade D).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</a:tr>
              <a:tr h="8902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ageInMonth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24&lt;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i_bmiPercenti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85&lt;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|pi_deltaBMI</a:t>
                      </a:r>
                      <a:endParaRPr lang="en-US" sz="1200" b="0" i="0" u="none" strike="noStrike">
                        <a:solidFill>
                          <a:srgbClr val="9C0006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excessiveIncrease</a:t>
                      </a:r>
                      <a:endParaRPr lang="en-US" sz="1200" b="0" i="0" u="none" strike="noStrike">
                        <a:solidFill>
                          <a:srgbClr val="9C0006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|pi_deltaBMI</a:t>
                      </a:r>
                      <a:endParaRPr lang="en-US" sz="1200" b="0" i="0" u="none" strike="noStrike">
                        <a:solidFill>
                          <a:srgbClr val="9C0006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increasing</a:t>
                      </a:r>
                      <a:endParaRPr lang="en-US" sz="1200" b="0" i="0" u="none" strike="noStrike">
                        <a:solidFill>
                          <a:srgbClr val="9C0006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OO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RD Counseling and P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</a:rPr>
                        <a:t>RD counseling for energy balanced diet, intensify physical activity recommendations, follow up in 6 months (Grade D).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382" marR="3382" marT="3382" marB="0" anchor="ctr"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70329" y="5378229"/>
            <a:ext cx="23622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ructured data: Inventory of data elements and logic required to implement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83596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42899" y="5176157"/>
            <a:ext cx="370658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xecutable layer: Excerpt of machine-readable code for implementation within application.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72" r="25224" b="67469"/>
          <a:stretch/>
        </p:blipFill>
        <p:spPr>
          <a:xfrm>
            <a:off x="1338123" y="1352551"/>
            <a:ext cx="10555362" cy="2800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34014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417</Words>
  <Application>Microsoft Office PowerPoint</Application>
  <PresentationFormat>Widescreen</PresentationFormat>
  <Paragraphs>107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RTI Internationa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urberg, Robert</dc:creator>
  <cp:lastModifiedBy>Furberg, Robert</cp:lastModifiedBy>
  <cp:revision>7</cp:revision>
  <dcterms:created xsi:type="dcterms:W3CDTF">2016-11-28T16:06:09Z</dcterms:created>
  <dcterms:modified xsi:type="dcterms:W3CDTF">2016-11-28T18:22:20Z</dcterms:modified>
</cp:coreProperties>
</file>